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6" r:id="rId3"/>
    <p:sldId id="456" r:id="rId4"/>
    <p:sldId id="463" r:id="rId5"/>
    <p:sldId id="464" r:id="rId6"/>
    <p:sldId id="465" r:id="rId7"/>
    <p:sldId id="261" r:id="rId8"/>
    <p:sldId id="462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8892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114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viewProps" Target="viewProps.xml"/><Relationship Id="rId5" Type="http://schemas.openxmlformats.org/officeDocument/2006/relationships/slide" Target="slides/slide3.xml"/><Relationship Id="rId10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slide" Target="slides/slide7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10.140.121.90\Sutphin%20server\Users\Previous%20students\Talia%20Sugden\Experiments\Bacterial%20Growth%20experiments\Lagtime%20(OP50%20v.%20PA14)\Dilution%20vs%20Lagtime%20OP50%20vs%20PA14%20Run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10.140.121.90\Sutphin%20server\Users\Previous%20students\Talia%20Sugden\Experiments\Bacterial%20Growth%20experiments\Lagtime%20(OP50%20v.%20PA14)\Dilution%20vs%20Lagtime%20OP50%20vs%20PA14%20Run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400" b="0" i="0" u="none" strike="noStrike" kern="1200" spc="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en-US" sz="1800" b="0" i="0" baseline="0">
                <a:effectLst/>
              </a:rPr>
              <a:t>GOP50 OD600 v Lagtime</a:t>
            </a:r>
            <a:endParaRPr lang="en-US">
              <a:effectLst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>
                <a:solidFill>
                  <a:sysClr val="windowText" lastClr="000000">
                    <a:lumMod val="65000"/>
                    <a:lumOff val="35000"/>
                  </a:sysClr>
                </a:solidFill>
              </a:defRPr>
            </a:pP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400" b="0" i="0" u="none" strike="noStrike" kern="1200" spc="0" baseline="0">
              <a:solidFill>
                <a:sysClr val="windowText" lastClr="000000">
                  <a:lumMod val="65000"/>
                  <a:lumOff val="35000"/>
                </a:sys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627973957050993"/>
          <c:y val="0.13546872309105773"/>
          <c:w val="0.67731874049420793"/>
          <c:h val="0.69388582075537131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2.0516185476815397E-4"/>
                  <c:y val="-5.882910469524643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Plate 1 - Sheet1 (2)'!$Q$346:$Q$352</c:f>
              <c:numCache>
                <c:formatCode>General</c:formatCode>
                <c:ptCount val="7"/>
                <c:pt idx="0">
                  <c:v>0.04</c:v>
                </c:pt>
                <c:pt idx="1">
                  <c:v>0.02</c:v>
                </c:pt>
                <c:pt idx="2">
                  <c:v>0.01</c:v>
                </c:pt>
                <c:pt idx="3">
                  <c:v>5.0000000000000001E-3</c:v>
                </c:pt>
                <c:pt idx="4">
                  <c:v>2.5000000000000001E-3</c:v>
                </c:pt>
                <c:pt idx="5">
                  <c:v>1.25E-3</c:v>
                </c:pt>
                <c:pt idx="6">
                  <c:v>6.2500000000000001E-4</c:v>
                </c:pt>
              </c:numCache>
            </c:numRef>
          </c:xVal>
          <c:yVal>
            <c:numRef>
              <c:f>'Plate 1 - Sheet1 (2)'!$R$346:$R$352</c:f>
              <c:numCache>
                <c:formatCode>General</c:formatCode>
                <c:ptCount val="7"/>
                <c:pt idx="0">
                  <c:v>1.9469983775013521E-4</c:v>
                </c:pt>
                <c:pt idx="1">
                  <c:v>1.1479591836734695E-4</c:v>
                </c:pt>
                <c:pt idx="2">
                  <c:v>7.101376088877666E-5</c:v>
                </c:pt>
                <c:pt idx="3">
                  <c:v>5.3801686981785127E-5</c:v>
                </c:pt>
                <c:pt idx="4">
                  <c:v>3.9889196675900274E-5</c:v>
                </c:pt>
                <c:pt idx="5">
                  <c:v>3.0189590629151075E-5</c:v>
                </c:pt>
                <c:pt idx="6">
                  <c:v>2.4426718487497589E-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999-4469-A6D5-9836438E4A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00755280"/>
        <c:axId val="1700750288"/>
      </c:scatterChart>
      <c:valAx>
        <c:axId val="170075528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/>
                  <a:t> OP50 Theoretical</a:t>
                </a:r>
                <a:r>
                  <a:rPr lang="en-US" sz="1600" baseline="0"/>
                  <a:t> OD</a:t>
                </a:r>
                <a:endParaRPr lang="en-US" sz="16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00750288"/>
        <c:crosses val="autoZero"/>
        <c:crossBetween val="midCat"/>
      </c:valAx>
      <c:valAx>
        <c:axId val="17007502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0" i="0" baseline="0">
                    <a:effectLst/>
                  </a:rPr>
                  <a:t>(1/Lagtime)^2</a:t>
                </a:r>
                <a:endParaRPr lang="en-US" baseline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defRPr>
                </a:pPr>
                <a:r>
                  <a:rPr lang="en-US" baseline="0"/>
                  <a:t> </a:t>
                </a:r>
              </a:p>
            </c:rich>
          </c:tx>
          <c:layout>
            <c:manualLayout>
              <c:xMode val="edge"/>
              <c:yMode val="edge"/>
              <c:x val="2.7777850763105391E-2"/>
              <c:y val="0.2774655747128582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0075528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aseline="0"/>
              <a:t>GPA14 OD600 v Lagtime</a:t>
            </a: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5.2144138232720912E-2"/>
                  <c:y val="-5.4629629629629629E-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[Dilution vs Lagtime OP50 vs PA14 Run1.xlsx]Plate 1 - Sheet1 (2)'!$Y$346:$Y$352</c:f>
              <c:numCache>
                <c:formatCode>General</c:formatCode>
                <c:ptCount val="7"/>
                <c:pt idx="0">
                  <c:v>0.04</c:v>
                </c:pt>
                <c:pt idx="1">
                  <c:v>0.02</c:v>
                </c:pt>
                <c:pt idx="2">
                  <c:v>0.01</c:v>
                </c:pt>
                <c:pt idx="3">
                  <c:v>5.0000000000000001E-3</c:v>
                </c:pt>
                <c:pt idx="4">
                  <c:v>2.5000000000000001E-3</c:v>
                </c:pt>
                <c:pt idx="5">
                  <c:v>1.25E-3</c:v>
                </c:pt>
              </c:numCache>
            </c:numRef>
          </c:xVal>
          <c:yVal>
            <c:numRef>
              <c:f>'[Dilution vs Lagtime OP50 vs PA14 Run1.xlsx]Plate 1 - Sheet1 (2)'!$Z$346:$Z$352</c:f>
              <c:numCache>
                <c:formatCode>General</c:formatCode>
                <c:ptCount val="7"/>
                <c:pt idx="0">
                  <c:v>1.6577943966549394E-4</c:v>
                </c:pt>
                <c:pt idx="1">
                  <c:v>9.8679882461295533E-5</c:v>
                </c:pt>
                <c:pt idx="2">
                  <c:v>6.4342703537418849E-5</c:v>
                </c:pt>
                <c:pt idx="3">
                  <c:v>5.2764570349829104E-5</c:v>
                </c:pt>
                <c:pt idx="4">
                  <c:v>3.4875069750139496E-5</c:v>
                </c:pt>
                <c:pt idx="5">
                  <c:v>2.6570305027101709E-5</c:v>
                </c:pt>
                <c:pt idx="6">
                  <c:v>6.7699255834735587E-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221-4B69-9992-03F64C5D94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64046944"/>
        <c:axId val="1217818784"/>
      </c:scatterChart>
      <c:valAx>
        <c:axId val="1064046944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/>
                  <a:t>PA14</a:t>
                </a:r>
                <a:r>
                  <a:rPr lang="en-US" sz="1600" baseline="0"/>
                  <a:t> theoretical OD</a:t>
                </a:r>
                <a:endParaRPr lang="en-US" sz="16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17818784"/>
        <c:crosses val="autoZero"/>
        <c:crossBetween val="midCat"/>
      </c:valAx>
      <c:valAx>
        <c:axId val="12178187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0" i="0" baseline="0">
                    <a:effectLst/>
                  </a:rPr>
                  <a:t>(1/Lagtime)^2</a:t>
                </a:r>
                <a:endParaRPr lang="en-US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defRPr>
                </a:pPr>
                <a:endParaRPr lang="en-US"/>
              </a:p>
            </c:rich>
          </c:tx>
          <c:layout>
            <c:manualLayout>
              <c:xMode val="edge"/>
              <c:yMode val="edge"/>
              <c:x val="3.0555487555178344E-2"/>
              <c:y val="0.2996608304498054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40469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BCC91-BC1A-825C-30C5-29A4759FD9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AF61E4-10AC-942D-1ACE-E6390B29388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954FA4-4BFC-D312-DD0A-E4110E142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8F89A-45DB-41F9-87AF-899EA61A32EF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1746CA-AF9C-D821-0FFC-1F7938140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27BC8C-9C5E-69D9-3F64-6945EAF0B4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44F6A-EAAF-4570-ABB2-E3247007F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380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B7F77B-AFFE-F4CB-A4A3-65020617D1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3DA590-9CC9-081D-0981-A2B7940E3A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27CEF9-6610-89D6-D6CA-D5BC790077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8F89A-45DB-41F9-87AF-899EA61A32EF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A78E6C-1686-2986-9FDF-7850A7EA1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E992CB-66DF-065A-7033-69ACB5384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44F6A-EAAF-4570-ABB2-E3247007F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1470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1BB04D-2452-98A1-8D37-1F02C1729C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B579C7-DBE8-561F-1AF9-09F29F0AC8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60A4D8-3DB7-9866-E8AA-CBC49F32C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8F89A-45DB-41F9-87AF-899EA61A32EF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D3EB52-34C9-7D1E-1D47-B316198A8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38CEEF-14A4-95BF-673A-89B986177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44F6A-EAAF-4570-ABB2-E3247007F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3062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31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246"/>
            </a:lvl1pPr>
            <a:lvl2pPr marL="237424" indent="0" algn="ctr">
              <a:buNone/>
              <a:defRPr sz="1039"/>
            </a:lvl2pPr>
            <a:lvl3pPr marL="474848" indent="0" algn="ctr">
              <a:buNone/>
              <a:defRPr sz="935"/>
            </a:lvl3pPr>
            <a:lvl4pPr marL="712272" indent="0" algn="ctr">
              <a:buNone/>
              <a:defRPr sz="831"/>
            </a:lvl4pPr>
            <a:lvl5pPr marL="949696" indent="0" algn="ctr">
              <a:buNone/>
              <a:defRPr sz="831"/>
            </a:lvl5pPr>
            <a:lvl6pPr marL="1187120" indent="0" algn="ctr">
              <a:buNone/>
              <a:defRPr sz="831"/>
            </a:lvl6pPr>
            <a:lvl7pPr marL="1424544" indent="0" algn="ctr">
              <a:buNone/>
              <a:defRPr sz="831"/>
            </a:lvl7pPr>
            <a:lvl8pPr marL="1661968" indent="0" algn="ctr">
              <a:buNone/>
              <a:defRPr sz="831"/>
            </a:lvl8pPr>
            <a:lvl9pPr marL="1899392" indent="0" algn="ctr">
              <a:buNone/>
              <a:defRPr sz="83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17E7-D056-421A-868D-2033A3AEB25B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70BCC-12E2-4588-AB3C-696716158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72349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17E7-D056-421A-868D-2033A3AEB25B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70BCC-12E2-4588-AB3C-696716158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28427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9"/>
            <a:ext cx="10515600" cy="2852737"/>
          </a:xfrm>
        </p:spPr>
        <p:txBody>
          <a:bodyPr anchor="b"/>
          <a:lstStyle>
            <a:lvl1pPr>
              <a:defRPr sz="31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5"/>
            <a:ext cx="10515600" cy="1500187"/>
          </a:xfrm>
        </p:spPr>
        <p:txBody>
          <a:bodyPr/>
          <a:lstStyle>
            <a:lvl1pPr marL="0" indent="0">
              <a:buNone/>
              <a:defRPr sz="1246">
                <a:solidFill>
                  <a:schemeClr val="tx1"/>
                </a:solidFill>
              </a:defRPr>
            </a:lvl1pPr>
            <a:lvl2pPr marL="237424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2pPr>
            <a:lvl3pPr marL="474848" indent="0">
              <a:buNone/>
              <a:defRPr sz="935">
                <a:solidFill>
                  <a:schemeClr val="tx1">
                    <a:tint val="75000"/>
                  </a:schemeClr>
                </a:solidFill>
              </a:defRPr>
            </a:lvl3pPr>
            <a:lvl4pPr marL="712272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4pPr>
            <a:lvl5pPr marL="949696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5pPr>
            <a:lvl6pPr marL="1187120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6pPr>
            <a:lvl7pPr marL="1424544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7pPr>
            <a:lvl8pPr marL="1661968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8pPr>
            <a:lvl9pPr marL="1899392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17E7-D056-421A-868D-2033A3AEB25B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70BCC-12E2-4588-AB3C-696716158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65014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17E7-D056-421A-868D-2033A3AEB25B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70BCC-12E2-4588-AB3C-696716158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72408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1246" b="1"/>
            </a:lvl1pPr>
            <a:lvl2pPr marL="237424" indent="0">
              <a:buNone/>
              <a:defRPr sz="1039" b="1"/>
            </a:lvl2pPr>
            <a:lvl3pPr marL="474848" indent="0">
              <a:buNone/>
              <a:defRPr sz="935" b="1"/>
            </a:lvl3pPr>
            <a:lvl4pPr marL="712272" indent="0">
              <a:buNone/>
              <a:defRPr sz="831" b="1"/>
            </a:lvl4pPr>
            <a:lvl5pPr marL="949696" indent="0">
              <a:buNone/>
              <a:defRPr sz="831" b="1"/>
            </a:lvl5pPr>
            <a:lvl6pPr marL="1187120" indent="0">
              <a:buNone/>
              <a:defRPr sz="831" b="1"/>
            </a:lvl6pPr>
            <a:lvl7pPr marL="1424544" indent="0">
              <a:buNone/>
              <a:defRPr sz="831" b="1"/>
            </a:lvl7pPr>
            <a:lvl8pPr marL="1661968" indent="0">
              <a:buNone/>
              <a:defRPr sz="831" b="1"/>
            </a:lvl8pPr>
            <a:lvl9pPr marL="1899392" indent="0">
              <a:buNone/>
              <a:defRPr sz="83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1246" b="1"/>
            </a:lvl1pPr>
            <a:lvl2pPr marL="237424" indent="0">
              <a:buNone/>
              <a:defRPr sz="1039" b="1"/>
            </a:lvl2pPr>
            <a:lvl3pPr marL="474848" indent="0">
              <a:buNone/>
              <a:defRPr sz="935" b="1"/>
            </a:lvl3pPr>
            <a:lvl4pPr marL="712272" indent="0">
              <a:buNone/>
              <a:defRPr sz="831" b="1"/>
            </a:lvl4pPr>
            <a:lvl5pPr marL="949696" indent="0">
              <a:buNone/>
              <a:defRPr sz="831" b="1"/>
            </a:lvl5pPr>
            <a:lvl6pPr marL="1187120" indent="0">
              <a:buNone/>
              <a:defRPr sz="831" b="1"/>
            </a:lvl6pPr>
            <a:lvl7pPr marL="1424544" indent="0">
              <a:buNone/>
              <a:defRPr sz="831" b="1"/>
            </a:lvl7pPr>
            <a:lvl8pPr marL="1661968" indent="0">
              <a:buNone/>
              <a:defRPr sz="831" b="1"/>
            </a:lvl8pPr>
            <a:lvl9pPr marL="1899392" indent="0">
              <a:buNone/>
              <a:defRPr sz="83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17E7-D056-421A-868D-2033A3AEB25B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70BCC-12E2-4588-AB3C-696716158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43759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17E7-D056-421A-868D-2033A3AEB25B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70BCC-12E2-4588-AB3C-696716158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47943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17E7-D056-421A-868D-2033A3AEB25B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70BCC-12E2-4588-AB3C-696716158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1500856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166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1662"/>
            </a:lvl1pPr>
            <a:lvl2pPr>
              <a:defRPr sz="1454"/>
            </a:lvl2pPr>
            <a:lvl3pPr>
              <a:defRPr sz="1246"/>
            </a:lvl3pPr>
            <a:lvl4pPr>
              <a:defRPr sz="1039"/>
            </a:lvl4pPr>
            <a:lvl5pPr>
              <a:defRPr sz="1039"/>
            </a:lvl5pPr>
            <a:lvl6pPr>
              <a:defRPr sz="1039"/>
            </a:lvl6pPr>
            <a:lvl7pPr>
              <a:defRPr sz="1039"/>
            </a:lvl7pPr>
            <a:lvl8pPr>
              <a:defRPr sz="1039"/>
            </a:lvl8pPr>
            <a:lvl9pPr>
              <a:defRPr sz="10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831"/>
            </a:lvl1pPr>
            <a:lvl2pPr marL="237424" indent="0">
              <a:buNone/>
              <a:defRPr sz="727"/>
            </a:lvl2pPr>
            <a:lvl3pPr marL="474848" indent="0">
              <a:buNone/>
              <a:defRPr sz="623"/>
            </a:lvl3pPr>
            <a:lvl4pPr marL="712272" indent="0">
              <a:buNone/>
              <a:defRPr sz="519"/>
            </a:lvl4pPr>
            <a:lvl5pPr marL="949696" indent="0">
              <a:buNone/>
              <a:defRPr sz="519"/>
            </a:lvl5pPr>
            <a:lvl6pPr marL="1187120" indent="0">
              <a:buNone/>
              <a:defRPr sz="519"/>
            </a:lvl6pPr>
            <a:lvl7pPr marL="1424544" indent="0">
              <a:buNone/>
              <a:defRPr sz="519"/>
            </a:lvl7pPr>
            <a:lvl8pPr marL="1661968" indent="0">
              <a:buNone/>
              <a:defRPr sz="519"/>
            </a:lvl8pPr>
            <a:lvl9pPr marL="1899392" indent="0">
              <a:buNone/>
              <a:defRPr sz="51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17E7-D056-421A-868D-2033A3AEB25B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70BCC-12E2-4588-AB3C-696716158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935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BB4099-E70F-8A9A-B421-CC4911B8E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9DB4CF-EBFB-614A-DEE4-671BDDCAA7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25BA30-E594-E66B-72A7-B1E30D6D6C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8F89A-45DB-41F9-87AF-899EA61A32EF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9341CD-4CFC-E7C0-4D5B-636EE6D99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9A7CB7-6300-2254-A57E-1917F6376A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44F6A-EAAF-4570-ABB2-E3247007F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044868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166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1662"/>
            </a:lvl1pPr>
            <a:lvl2pPr marL="237424" indent="0">
              <a:buNone/>
              <a:defRPr sz="1454"/>
            </a:lvl2pPr>
            <a:lvl3pPr marL="474848" indent="0">
              <a:buNone/>
              <a:defRPr sz="1246"/>
            </a:lvl3pPr>
            <a:lvl4pPr marL="712272" indent="0">
              <a:buNone/>
              <a:defRPr sz="1039"/>
            </a:lvl4pPr>
            <a:lvl5pPr marL="949696" indent="0">
              <a:buNone/>
              <a:defRPr sz="1039"/>
            </a:lvl5pPr>
            <a:lvl6pPr marL="1187120" indent="0">
              <a:buNone/>
              <a:defRPr sz="1039"/>
            </a:lvl6pPr>
            <a:lvl7pPr marL="1424544" indent="0">
              <a:buNone/>
              <a:defRPr sz="1039"/>
            </a:lvl7pPr>
            <a:lvl8pPr marL="1661968" indent="0">
              <a:buNone/>
              <a:defRPr sz="1039"/>
            </a:lvl8pPr>
            <a:lvl9pPr marL="1899392" indent="0">
              <a:buNone/>
              <a:defRPr sz="103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831"/>
            </a:lvl1pPr>
            <a:lvl2pPr marL="237424" indent="0">
              <a:buNone/>
              <a:defRPr sz="727"/>
            </a:lvl2pPr>
            <a:lvl3pPr marL="474848" indent="0">
              <a:buNone/>
              <a:defRPr sz="623"/>
            </a:lvl3pPr>
            <a:lvl4pPr marL="712272" indent="0">
              <a:buNone/>
              <a:defRPr sz="519"/>
            </a:lvl4pPr>
            <a:lvl5pPr marL="949696" indent="0">
              <a:buNone/>
              <a:defRPr sz="519"/>
            </a:lvl5pPr>
            <a:lvl6pPr marL="1187120" indent="0">
              <a:buNone/>
              <a:defRPr sz="519"/>
            </a:lvl6pPr>
            <a:lvl7pPr marL="1424544" indent="0">
              <a:buNone/>
              <a:defRPr sz="519"/>
            </a:lvl7pPr>
            <a:lvl8pPr marL="1661968" indent="0">
              <a:buNone/>
              <a:defRPr sz="519"/>
            </a:lvl8pPr>
            <a:lvl9pPr marL="1899392" indent="0">
              <a:buNone/>
              <a:defRPr sz="51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17E7-D056-421A-868D-2033A3AEB25B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70BCC-12E2-4588-AB3C-696716158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19141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17E7-D056-421A-868D-2033A3AEB25B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70BCC-12E2-4588-AB3C-696716158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570628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2117E7-D056-421A-868D-2033A3AEB25B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70BCC-12E2-4588-AB3C-696716158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6911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19BC84-780F-9171-420F-22FADFA99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96F907-AD54-DDBD-8D97-35F931656B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823BEE-6091-171D-395A-5C4FB87B8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8F89A-45DB-41F9-87AF-899EA61A32EF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EC1500-BBA1-C9A3-0F45-409A473EE5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8F4ECE-0EFC-2B2E-5C54-B75C601E0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44F6A-EAAF-4570-ABB2-E3247007F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886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FFA5F8-D853-708B-DC92-2025F290A9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C837F2-A8F2-2BD5-82F6-69F5B282E1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A41DE4-EF49-BA10-CDD1-5C361B2785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9C3DB3-38E2-AC34-61C4-8F3455712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8F89A-45DB-41F9-87AF-899EA61A32EF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88D408-2D9B-BB01-B398-69C925890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0BDA03-86D2-E764-15E8-07624FF5F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44F6A-EAAF-4570-ABB2-E3247007F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349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4E8D3A-99C8-DA30-B778-414D38CBB9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83C0FC-0AB5-B61C-6E09-94AA8C0577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BFCDDB-0545-FF14-95AA-A89F181E8D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7D21783-EF8D-5C4B-BCE8-ED1771B916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BD1E290-C863-5F46-84DE-60D984E76C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3F2F746-E96B-6104-F5BF-9F41F9EED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8F89A-45DB-41F9-87AF-899EA61A32EF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8054DC-1903-79C6-D756-8A192855E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8D4EA85-0E3F-A2DD-F333-E8D0E7FAF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44F6A-EAAF-4570-ABB2-E3247007F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5802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44DEDF-C86A-1C94-12C9-E5ABB77D6F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689C94B-112A-C5AF-8212-A9F141363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8F89A-45DB-41F9-87AF-899EA61A32EF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EAFEA2C-6751-4537-1955-759FC8DD3D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BF10027-7AC5-FBDC-ACFD-71B5AB2287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44F6A-EAAF-4570-ABB2-E3247007F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506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D7CD45D-3C88-411B-7C20-C040024FB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8F89A-45DB-41F9-87AF-899EA61A32EF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5B25A8E-B531-50F7-871B-868BD7C04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BAE584-2A19-8ED6-4BFA-17755FFD63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44F6A-EAAF-4570-ABB2-E3247007F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245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B41A9F-90A7-93F0-88B1-B2C16A1EC2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CF3267-2B49-E642-E4F6-7BA39906EE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755C71-AC77-DD41-6CB2-6269BF1AE8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98EB1A-1973-4346-E3F2-5F7351FE7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8F89A-45DB-41F9-87AF-899EA61A32EF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D400BC-5790-E7B6-4235-0B8AAD6E71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94FE8F-DBBB-55CF-3197-89C2D486E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44F6A-EAAF-4570-ABB2-E3247007F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9020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A99B89-7DB1-788E-87A2-C6926B1F86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8B5E553-1846-B298-C5AA-0E562F9EAF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9750C4-BCF7-1D5F-ABF4-218C70187C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2F88CD-9350-BCFC-D58C-2F549C70EB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48F89A-45DB-41F9-87AF-899EA61A32EF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B05E5B-0446-5361-1158-BA641ADE46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76530D-116F-F7AC-BAB3-F1D7804C17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344F6A-EAAF-4570-ABB2-E3247007F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7282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D06D17-4E60-64CA-034E-9004B26E18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CBDA2D-4CFD-650F-CAD5-D3E0324D2A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E253D7-9251-1978-9DE1-AA08AA9D07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48F89A-45DB-41F9-87AF-899EA61A32EF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73AFBB-2153-B2C0-058C-F9F6611C491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4AB34C-E2E3-688D-E384-EA2DE4CB63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344F6A-EAAF-4570-ABB2-E3247007F9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359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2117E7-D056-421A-868D-2033A3AEB25B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70BCC-12E2-4588-AB3C-696716158A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3638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474848" rtl="0" eaLnBrk="1" latinLnBrk="0" hangingPunct="1">
        <a:lnSpc>
          <a:spcPct val="90000"/>
        </a:lnSpc>
        <a:spcBef>
          <a:spcPct val="0"/>
        </a:spcBef>
        <a:buNone/>
        <a:defRPr sz="228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8712" indent="-118712" algn="l" defTabSz="474848" rtl="0" eaLnBrk="1" latinLnBrk="0" hangingPunct="1">
        <a:lnSpc>
          <a:spcPct val="90000"/>
        </a:lnSpc>
        <a:spcBef>
          <a:spcPts val="519"/>
        </a:spcBef>
        <a:buFont typeface="Arial" panose="020B0604020202020204" pitchFamily="34" charset="0"/>
        <a:buChar char="•"/>
        <a:defRPr sz="1454" kern="1200">
          <a:solidFill>
            <a:schemeClr val="tx1"/>
          </a:solidFill>
          <a:latin typeface="+mn-lt"/>
          <a:ea typeface="+mn-ea"/>
          <a:cs typeface="+mn-cs"/>
        </a:defRPr>
      </a:lvl1pPr>
      <a:lvl2pPr marL="356136" indent="-118712" algn="l" defTabSz="474848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593560" indent="-118712" algn="l" defTabSz="474848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1039" kern="1200">
          <a:solidFill>
            <a:schemeClr val="tx1"/>
          </a:solidFill>
          <a:latin typeface="+mn-lt"/>
          <a:ea typeface="+mn-ea"/>
          <a:cs typeface="+mn-cs"/>
        </a:defRPr>
      </a:lvl3pPr>
      <a:lvl4pPr marL="830984" indent="-118712" algn="l" defTabSz="474848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4pPr>
      <a:lvl5pPr marL="1068408" indent="-118712" algn="l" defTabSz="474848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5pPr>
      <a:lvl6pPr marL="1305832" indent="-118712" algn="l" defTabSz="474848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6pPr>
      <a:lvl7pPr marL="1543256" indent="-118712" algn="l" defTabSz="474848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7pPr>
      <a:lvl8pPr marL="1780680" indent="-118712" algn="l" defTabSz="474848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8pPr>
      <a:lvl9pPr marL="2018104" indent="-118712" algn="l" defTabSz="474848" rtl="0" eaLnBrk="1" latinLnBrk="0" hangingPunct="1">
        <a:lnSpc>
          <a:spcPct val="90000"/>
        </a:lnSpc>
        <a:spcBef>
          <a:spcPts val="260"/>
        </a:spcBef>
        <a:buFont typeface="Arial" panose="020B0604020202020204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74848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1pPr>
      <a:lvl2pPr marL="237424" algn="l" defTabSz="474848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2pPr>
      <a:lvl3pPr marL="474848" algn="l" defTabSz="474848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3pPr>
      <a:lvl4pPr marL="712272" algn="l" defTabSz="474848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4pPr>
      <a:lvl5pPr marL="949696" algn="l" defTabSz="474848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5pPr>
      <a:lvl6pPr marL="1187120" algn="l" defTabSz="474848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6pPr>
      <a:lvl7pPr marL="1424544" algn="l" defTabSz="474848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7pPr>
      <a:lvl8pPr marL="1661968" algn="l" defTabSz="474848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8pPr>
      <a:lvl9pPr marL="1899392" algn="l" defTabSz="474848" rtl="0" eaLnBrk="1" latinLnBrk="0" hangingPunct="1">
        <a:defRPr sz="9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8.emf"/><Relationship Id="rId18" Type="http://schemas.openxmlformats.org/officeDocument/2006/relationships/oleObject" Target="../embeddings/oleObject9.bin"/><Relationship Id="rId3" Type="http://schemas.openxmlformats.org/officeDocument/2006/relationships/image" Target="../media/image3.emf"/><Relationship Id="rId7" Type="http://schemas.openxmlformats.org/officeDocument/2006/relationships/image" Target="../media/image5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10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13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7.emf"/><Relationship Id="rId5" Type="http://schemas.openxmlformats.org/officeDocument/2006/relationships/image" Target="../media/image4.emf"/><Relationship Id="rId15" Type="http://schemas.openxmlformats.org/officeDocument/2006/relationships/image" Target="../media/image9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11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6.emf"/><Relationship Id="rId14" Type="http://schemas.openxmlformats.org/officeDocument/2006/relationships/oleObject" Target="../embeddings/oleObject7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3.bin"/><Relationship Id="rId13" Type="http://schemas.openxmlformats.org/officeDocument/2006/relationships/image" Target="../media/image17.emf"/><Relationship Id="rId18" Type="http://schemas.openxmlformats.org/officeDocument/2006/relationships/oleObject" Target="../embeddings/oleObject18.bin"/><Relationship Id="rId3" Type="http://schemas.openxmlformats.org/officeDocument/2006/relationships/image" Target="../media/image12.emf"/><Relationship Id="rId21" Type="http://schemas.openxmlformats.org/officeDocument/2006/relationships/image" Target="../media/image21.emf"/><Relationship Id="rId7" Type="http://schemas.openxmlformats.org/officeDocument/2006/relationships/image" Target="../media/image14.emf"/><Relationship Id="rId12" Type="http://schemas.openxmlformats.org/officeDocument/2006/relationships/oleObject" Target="../embeddings/oleObject15.bin"/><Relationship Id="rId17" Type="http://schemas.openxmlformats.org/officeDocument/2006/relationships/image" Target="../media/image19.emf"/><Relationship Id="rId2" Type="http://schemas.openxmlformats.org/officeDocument/2006/relationships/oleObject" Target="../embeddings/oleObject10.bin"/><Relationship Id="rId16" Type="http://schemas.openxmlformats.org/officeDocument/2006/relationships/oleObject" Target="../embeddings/oleObject17.bin"/><Relationship Id="rId20" Type="http://schemas.openxmlformats.org/officeDocument/2006/relationships/oleObject" Target="../embeddings/oleObject19.bin"/><Relationship Id="rId1" Type="http://schemas.openxmlformats.org/officeDocument/2006/relationships/slideLayout" Target="../slideLayouts/slideLayout13.xml"/><Relationship Id="rId6" Type="http://schemas.openxmlformats.org/officeDocument/2006/relationships/oleObject" Target="../embeddings/oleObject12.bin"/><Relationship Id="rId11" Type="http://schemas.openxmlformats.org/officeDocument/2006/relationships/image" Target="../media/image16.emf"/><Relationship Id="rId5" Type="http://schemas.openxmlformats.org/officeDocument/2006/relationships/image" Target="../media/image13.emf"/><Relationship Id="rId15" Type="http://schemas.openxmlformats.org/officeDocument/2006/relationships/image" Target="../media/image18.emf"/><Relationship Id="rId10" Type="http://schemas.openxmlformats.org/officeDocument/2006/relationships/oleObject" Target="../embeddings/oleObject14.bin"/><Relationship Id="rId19" Type="http://schemas.openxmlformats.org/officeDocument/2006/relationships/image" Target="../media/image20.emf"/><Relationship Id="rId4" Type="http://schemas.openxmlformats.org/officeDocument/2006/relationships/oleObject" Target="../embeddings/oleObject11.bin"/><Relationship Id="rId9" Type="http://schemas.openxmlformats.org/officeDocument/2006/relationships/image" Target="../media/image15.emf"/><Relationship Id="rId14" Type="http://schemas.openxmlformats.org/officeDocument/2006/relationships/oleObject" Target="../embeddings/oleObject16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27.png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FCB483-CD69-6E38-0CFA-10DC190ADD6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l Figur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4EC078C-FC0D-B691-16EF-38396B741C8F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23875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6506C7C8-BBA3-24E2-38EF-CF33EFC218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48492" y="2136720"/>
            <a:ext cx="1520444" cy="151664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DEEFE87-4296-6096-DC8D-525A2E340F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68936" y="2136720"/>
            <a:ext cx="1521772" cy="1516643"/>
          </a:xfrm>
          <a:prstGeom prst="rect">
            <a:avLst/>
          </a:prstGeom>
        </p:spPr>
      </p:pic>
      <p:sp>
        <p:nvSpPr>
          <p:cNvPr id="6" name="Title 5">
            <a:extLst>
              <a:ext uri="{FF2B5EF4-FFF2-40B4-BE49-F238E27FC236}">
                <a16:creationId xmlns:a16="http://schemas.microsoft.com/office/drawing/2014/main" id="{568AB4B9-5C9E-3857-F3FA-D533B8A486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Figure 1: Power analysis of C. elegans in OP50 vs PA14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C190639-3EED-CBED-6D38-A8D7B46ADB2D}"/>
              </a:ext>
            </a:extLst>
          </p:cNvPr>
          <p:cNvSpPr/>
          <p:nvPr/>
        </p:nvSpPr>
        <p:spPr>
          <a:xfrm>
            <a:off x="3820020" y="2032988"/>
            <a:ext cx="4551960" cy="3667359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131902"/>
            <a:endParaRPr lang="en-US" sz="519">
              <a:solidFill>
                <a:prstClr val="white"/>
              </a:solidFill>
              <a:latin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24685138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0835D1-A329-9D10-2B35-A8DD823005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Figures 2: Mass spec of WT v haao-1 mutants in GOP50 vs GPA14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7CBC3BB-27B8-3C41-DEC1-A58C0E6697E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238509" y="3263039"/>
          <a:ext cx="980774" cy="8526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463785" imgH="3011794" progId="Prism8.Document">
                  <p:embed/>
                </p:oleObj>
              </mc:Choice>
              <mc:Fallback>
                <p:oleObj name="Prism 8" r:id="rId2" imgW="3463785" imgH="3011794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D7CBC3BB-27B8-3C41-DEC1-A58C0E6697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238509" y="3263039"/>
                        <a:ext cx="980774" cy="8526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BA010CD-8F67-E489-5765-BC0F4AB57FB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48492" y="2270242"/>
          <a:ext cx="1041339" cy="8526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610361" imgH="2955267" progId="Prism8.Document">
                  <p:embed/>
                </p:oleObj>
              </mc:Choice>
              <mc:Fallback>
                <p:oleObj name="Prism 8" r:id="rId4" imgW="3610361" imgH="2955267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9BA010CD-8F67-E489-5765-BC0F4AB57F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048492" y="2270242"/>
                        <a:ext cx="1041339" cy="8526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B9BBE7F2-ABA9-959B-C153-FB7DFA65642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143500" y="3246554"/>
          <a:ext cx="993714" cy="8856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445418" imgH="3069762" progId="Prism8.Document">
                  <p:embed/>
                </p:oleObj>
              </mc:Choice>
              <mc:Fallback>
                <p:oleObj name="Prism 8" r:id="rId6" imgW="3445418" imgH="3069762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B9BBE7F2-ABA9-959B-C153-FB7DFA65642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143500" y="3246554"/>
                        <a:ext cx="993714" cy="8856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5D670152-30C5-EAF1-2D90-640D4B09457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302378" y="3256857"/>
          <a:ext cx="1002415" cy="8650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474589" imgH="2999553" progId="Prism8.Document">
                  <p:embed/>
                </p:oleObj>
              </mc:Choice>
              <mc:Fallback>
                <p:oleObj name="Prism 8" r:id="rId8" imgW="3474589" imgH="2999553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5D670152-30C5-EAF1-2D90-640D4B0945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302378" y="3256857"/>
                        <a:ext cx="1002415" cy="8650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D63A614C-A7AC-AFCB-22A5-0D226D1A6A1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143500" y="2257878"/>
          <a:ext cx="1010200" cy="8650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3501960" imgH="2999553" progId="Prism8.Document">
                  <p:embed/>
                </p:oleObj>
              </mc:Choice>
              <mc:Fallback>
                <p:oleObj name="Prism 8" r:id="rId10" imgW="3501960" imgH="2999553" progId="Prism8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D63A614C-A7AC-AFCB-22A5-0D226D1A6A1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143500" y="2257878"/>
                        <a:ext cx="1010200" cy="8650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2ADD91CD-4CFE-9A6A-C87A-6FDE61D6B6F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207370" y="2257878"/>
          <a:ext cx="1015695" cy="8650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3520327" imgH="2999553" progId="Prism8.Document">
                  <p:embed/>
                </p:oleObj>
              </mc:Choice>
              <mc:Fallback>
                <p:oleObj name="Prism 8" r:id="rId12" imgW="3520327" imgH="2999553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2ADD91CD-4CFE-9A6A-C87A-6FDE61D6B6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207370" y="2257878"/>
                        <a:ext cx="1015695" cy="8650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75864530-F2D7-4B23-BE1D-07FD14C74A8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62046" y="3267161"/>
          <a:ext cx="1030807" cy="8650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3573627" imgH="2999553" progId="Prism8.Document">
                  <p:embed/>
                </p:oleObj>
              </mc:Choice>
              <mc:Fallback>
                <p:oleObj name="Prism 8" r:id="rId14" imgW="3573627" imgH="2999553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75864530-F2D7-4B23-BE1D-07FD14C74A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062046" y="3267161"/>
                        <a:ext cx="1030807" cy="8650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B5650B40-D463-474B-7BD5-A77A4ED39AC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276734" y="2270242"/>
          <a:ext cx="996919" cy="8650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3456222" imgH="2999553" progId="Prism8.Document">
                  <p:embed/>
                </p:oleObj>
              </mc:Choice>
              <mc:Fallback>
                <p:oleObj name="Prism 8" r:id="rId16" imgW="3456222" imgH="2999553" progId="Prism8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B5650B40-D463-474B-7BD5-A77A4ED39A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7276734" y="2270242"/>
                        <a:ext cx="996919" cy="8650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FCD0D0A8-249A-F5C9-7E43-0C752385D98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48492" y="4276445"/>
          <a:ext cx="1036302" cy="8650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3591994" imgH="2999553" progId="Prism8.Document">
                  <p:embed/>
                </p:oleObj>
              </mc:Choice>
              <mc:Fallback>
                <p:oleObj name="Prism 8" r:id="rId18" imgW="3591994" imgH="2999553" progId="Prism8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FCD0D0A8-249A-F5C9-7E43-0C752385D9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048492" y="4276445"/>
                        <a:ext cx="1036302" cy="8650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195923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CCEEA-08AD-D9F6-A43C-8F699FA840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-6348"/>
            <a:ext cx="10515600" cy="1325563"/>
          </a:xfrm>
        </p:spPr>
        <p:txBody>
          <a:bodyPr/>
          <a:lstStyle/>
          <a:p>
            <a:r>
              <a:rPr lang="en-US" dirty="0"/>
              <a:t>Supplemental Figure 3: Aging </a:t>
            </a:r>
            <a:r>
              <a:rPr lang="en-US" dirty="0" err="1"/>
              <a:t>Kyn</a:t>
            </a:r>
            <a:r>
              <a:rPr lang="en-US" dirty="0"/>
              <a:t> Mutant Mass Spec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486E38-9FA8-04E4-97C3-EAC2CBA947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454150"/>
            <a:ext cx="10515600" cy="4351338"/>
          </a:xfrm>
        </p:spPr>
        <p:txBody>
          <a:bodyPr/>
          <a:lstStyle/>
          <a:p>
            <a:endParaRPr lang="en-US" dirty="0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DBDC46B6-BE19-38EA-7E0B-9A0091C714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0136545"/>
              </p:ext>
            </p:extLst>
          </p:nvPr>
        </p:nvGraphicFramePr>
        <p:xfrm>
          <a:off x="1377953" y="1270705"/>
          <a:ext cx="2306636" cy="19077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625486" imgH="2999553" progId="Prism8.Document">
                  <p:embed/>
                </p:oleObj>
              </mc:Choice>
              <mc:Fallback>
                <p:oleObj name="Prism 8" r:id="rId2" imgW="3625486" imgH="299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377953" y="1270705"/>
                        <a:ext cx="2306636" cy="19077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76C0BE8D-5C86-EA8F-C081-BD51347318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920864"/>
              </p:ext>
            </p:extLst>
          </p:nvPr>
        </p:nvGraphicFramePr>
        <p:xfrm>
          <a:off x="3684589" y="2963795"/>
          <a:ext cx="2306636" cy="1880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678786" imgH="2999553" progId="Prism8.Document">
                  <p:embed/>
                </p:oleObj>
              </mc:Choice>
              <mc:Fallback>
                <p:oleObj name="Prism 8" r:id="rId4" imgW="3678786" imgH="299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84589" y="2963795"/>
                        <a:ext cx="2306636" cy="1880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5F192D9-5AA9-6584-904E-C845B1A404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267357"/>
              </p:ext>
            </p:extLst>
          </p:nvPr>
        </p:nvGraphicFramePr>
        <p:xfrm>
          <a:off x="5908676" y="2950209"/>
          <a:ext cx="2267249" cy="19077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564623" imgH="2999553" progId="Prism8.Document">
                  <p:embed/>
                </p:oleObj>
              </mc:Choice>
              <mc:Fallback>
                <p:oleObj name="Prism 8" r:id="rId6" imgW="3564623" imgH="299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908676" y="2950209"/>
                        <a:ext cx="2267249" cy="19077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CC087ED-BA48-50D9-57C8-9473C82ECD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0086804"/>
              </p:ext>
            </p:extLst>
          </p:nvPr>
        </p:nvGraphicFramePr>
        <p:xfrm>
          <a:off x="8215316" y="2950209"/>
          <a:ext cx="2339963" cy="19077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678786" imgH="2999553" progId="Prism8.Document">
                  <p:embed/>
                </p:oleObj>
              </mc:Choice>
              <mc:Fallback>
                <p:oleObj name="Prism 8" r:id="rId8" imgW="3678786" imgH="299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215316" y="2950209"/>
                        <a:ext cx="2339963" cy="19077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2ED66999-D187-9710-2407-9D1A34DFC55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987811"/>
              </p:ext>
            </p:extLst>
          </p:nvPr>
        </p:nvGraphicFramePr>
        <p:xfrm>
          <a:off x="3816351" y="1337312"/>
          <a:ext cx="1960562" cy="16264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3614682" imgH="2999553" progId="Prism8.Document">
                  <p:embed/>
                </p:oleObj>
              </mc:Choice>
              <mc:Fallback>
                <p:oleObj name="Prism 8" r:id="rId10" imgW="3614682" imgH="299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816351" y="1337312"/>
                        <a:ext cx="1960562" cy="16264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A8C065CF-35E6-14FB-630A-DC6A51E9CF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1696722"/>
              </p:ext>
            </p:extLst>
          </p:nvPr>
        </p:nvGraphicFramePr>
        <p:xfrm>
          <a:off x="5816304" y="1319215"/>
          <a:ext cx="1960562" cy="16264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3614682" imgH="2999553" progId="Prism8.Document">
                  <p:embed/>
                </p:oleObj>
              </mc:Choice>
              <mc:Fallback>
                <p:oleObj name="Prism 8" r:id="rId12" imgW="3614682" imgH="299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816304" y="1319215"/>
                        <a:ext cx="1960562" cy="16264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18907995-054A-FFE4-81F4-B787C4D038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6217714"/>
              </p:ext>
            </p:extLst>
          </p:nvPr>
        </p:nvGraphicFramePr>
        <p:xfrm>
          <a:off x="7908628" y="1373009"/>
          <a:ext cx="1960563" cy="16583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3614682" imgH="3057520" progId="Prism8.Document">
                  <p:embed/>
                </p:oleObj>
              </mc:Choice>
              <mc:Fallback>
                <p:oleObj name="Prism 8" r:id="rId14" imgW="3614682" imgH="305752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7908628" y="1373009"/>
                        <a:ext cx="1960563" cy="16583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40366887-AD22-17A8-9F94-F2A76CA5D0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8588013"/>
              </p:ext>
            </p:extLst>
          </p:nvPr>
        </p:nvGraphicFramePr>
        <p:xfrm>
          <a:off x="1377953" y="2879452"/>
          <a:ext cx="2306637" cy="19161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3610361" imgH="2999553" progId="Prism8.Document">
                  <p:embed/>
                </p:oleObj>
              </mc:Choice>
              <mc:Fallback>
                <p:oleObj name="Prism 8" r:id="rId16" imgW="3610361" imgH="299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377953" y="2879452"/>
                        <a:ext cx="2306637" cy="19161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777DA097-C08A-049C-A80E-40B7E4B42F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651694"/>
              </p:ext>
            </p:extLst>
          </p:nvPr>
        </p:nvGraphicFramePr>
        <p:xfrm>
          <a:off x="1329473" y="4748978"/>
          <a:ext cx="2315725" cy="19077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3640612" imgH="2999553" progId="Prism8.Document">
                  <p:embed/>
                </p:oleObj>
              </mc:Choice>
              <mc:Fallback>
                <p:oleObj name="Prism 8" r:id="rId18" imgW="3640612" imgH="299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329473" y="4748978"/>
                        <a:ext cx="2315725" cy="19077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E43DBF21-5F6A-F4AE-FF9D-D9F8C610CA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13251672"/>
              </p:ext>
            </p:extLst>
          </p:nvPr>
        </p:nvGraphicFramePr>
        <p:xfrm>
          <a:off x="3704282" y="4752371"/>
          <a:ext cx="2267249" cy="19043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0" imgW="3570385" imgH="2999553" progId="Prism8.Document">
                  <p:embed/>
                </p:oleObj>
              </mc:Choice>
              <mc:Fallback>
                <p:oleObj name="Prism 8" r:id="rId20" imgW="3570385" imgH="299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3704282" y="4752371"/>
                        <a:ext cx="2267249" cy="19043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9949956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73FFDF-54E2-7896-A8B8-ADEC9E5E36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l Figure 4: Bacterial Growth Dynamics in Relation to OD60</a:t>
            </a: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1FE1F221-40CE-41A4-BBAA-7742FDC7A8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58146012"/>
              </p:ext>
            </p:extLst>
          </p:nvPr>
        </p:nvGraphicFramePr>
        <p:xfrm>
          <a:off x="2032000" y="2023048"/>
          <a:ext cx="3362413" cy="34506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1E331027-D535-4A4A-90F2-F5ACA1B5A9D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61144450"/>
              </p:ext>
            </p:extLst>
          </p:nvPr>
        </p:nvGraphicFramePr>
        <p:xfrm>
          <a:off x="5470613" y="2158358"/>
          <a:ext cx="3362413" cy="31800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187357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7B1B01-39A7-0C45-4B5C-B835BCC5DF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94309"/>
            <a:ext cx="10515600" cy="1325563"/>
          </a:xfrm>
        </p:spPr>
        <p:txBody>
          <a:bodyPr/>
          <a:lstStyle/>
          <a:p>
            <a:r>
              <a:rPr lang="en-US" dirty="0"/>
              <a:t>Supplemental Figure 5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52B8960F-17C1-0320-4836-95DC267013D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5690903"/>
            <a:ext cx="10515600" cy="972787"/>
          </a:xfrm>
        </p:spPr>
        <p:txBody>
          <a:bodyPr/>
          <a:lstStyle/>
          <a:p>
            <a:pPr marL="0" indent="0">
              <a:buNone/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an neuronal GFP for VC neuronal markers (upper left) crossed with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Scralet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:HAAO-1 (upper right) </a:t>
            </a:r>
            <a:r>
              <a:rPr lang="en-US" sz="1800" i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. elegans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in N2 background under 40X confocal microscopy with separated and merged (bottom) images. </a:t>
            </a:r>
            <a:endParaRPr lang="en-US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EEC1AFB-FF7D-04E8-F95D-CBED61371E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4095" y="1167095"/>
            <a:ext cx="5723809" cy="4523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33667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917DF7-2F8B-49C1-A457-D6ED2ADE5A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24125" y="850907"/>
            <a:ext cx="6400800" cy="516205"/>
          </a:xfrm>
        </p:spPr>
        <p:txBody>
          <a:bodyPr>
            <a:normAutofit fontScale="90000"/>
          </a:bodyPr>
          <a:lstStyle/>
          <a:p>
            <a:r>
              <a:rPr lang="en-US" dirty="0"/>
              <a:t>Supplemental Figure 6: 3HAA exhibits antimicrobial activity enhanced by metal availability</a:t>
            </a:r>
          </a:p>
        </p:txBody>
      </p:sp>
      <p:pic>
        <p:nvPicPr>
          <p:cNvPr id="19" name="Content Placeholder 18">
            <a:extLst>
              <a:ext uri="{FF2B5EF4-FFF2-40B4-BE49-F238E27FC236}">
                <a16:creationId xmlns:a16="http://schemas.microsoft.com/office/drawing/2014/main" id="{8BE85806-D931-5A3D-848D-7B29158C5A9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857318" y="3294628"/>
            <a:ext cx="2130529" cy="20847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D7136FD-932A-4BC8-8F83-573964024C6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57319" y="1810234"/>
            <a:ext cx="2130530" cy="122411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C2CB599-838D-FAA6-743C-82694AAAC2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60019" y="1690963"/>
            <a:ext cx="1355105" cy="13569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2C8D45B-E7E2-260A-9340-3BF6177346B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18401" y="1690963"/>
            <a:ext cx="1355105" cy="13678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4245E28D-5133-040F-51DF-EB9084BFD61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53892" y="3294628"/>
            <a:ext cx="2842358" cy="22655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23795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2</TotalTime>
  <Words>133</Words>
  <Application>Microsoft Office PowerPoint</Application>
  <PresentationFormat>Widescreen</PresentationFormat>
  <Paragraphs>15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1_Office Theme</vt:lpstr>
      <vt:lpstr>Prism 8</vt:lpstr>
      <vt:lpstr>GraphPad Prism 8 Project</vt:lpstr>
      <vt:lpstr>Supplemental Figures</vt:lpstr>
      <vt:lpstr>Supplemental Figure 1: Power analysis of C. elegans in OP50 vs PA14</vt:lpstr>
      <vt:lpstr>Supplemental Figures 2: Mass spec of WT v haao-1 mutants in GOP50 vs GPA14</vt:lpstr>
      <vt:lpstr>Supplemental Figure 3: Aging Kyn Mutant Mass Spec</vt:lpstr>
      <vt:lpstr>Supplemental Figure 4: Bacterial Growth Dynamics in Relation to OD60</vt:lpstr>
      <vt:lpstr>Supplemental Figure 5</vt:lpstr>
      <vt:lpstr>Supplemental Figure 6: 3HAA exhibits antimicrobial activity enhanced by metal availability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</dc:title>
  <dc:creator>Espejo, Luis Santiago - (luise1)</dc:creator>
  <cp:lastModifiedBy>Luis Santiago Espejo</cp:lastModifiedBy>
  <cp:revision>4</cp:revision>
  <dcterms:created xsi:type="dcterms:W3CDTF">2024-01-05T19:35:08Z</dcterms:created>
  <dcterms:modified xsi:type="dcterms:W3CDTF">2024-01-08T00:57:41Z</dcterms:modified>
</cp:coreProperties>
</file>